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gif" ContentType="image/gif"/>
  <Override PartName="/ppt/media/image7.gif" ContentType="image/gif"/>
  <Override PartName="/ppt/media/image8.gif" ContentType="image/gif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118C06-388B-4993-92CA-CE950AB33672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51E3F8-A734-4EFF-B3A7-60BEB6E2672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82B195-BCBD-4260-AFD5-DBD17B40195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C12CFD-C3D5-4E74-B6ED-4638C556E17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3886E-F3C2-4E5B-A4BD-7F9194BFFB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A1D25-78E2-433F-9F12-0F13255617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AB0FF-B67D-436F-9D88-1630F74443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65052-B8F5-40A6-85BD-BD3033F05B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27199-49F0-4A5E-ACDA-55AEB3524B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34295-3B23-444C-9D45-C5A9D01DC5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E4CFA-73F1-49EE-9A1D-DFADA994AE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E513D-FBC2-4EAE-8226-2A0FE16866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003F0-E0B4-4928-8366-A0A31B7A0C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0CF69-927D-4E7D-A327-833811AB70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725A9-F976-4E94-BE60-F317C30BA0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272C9-C688-46A7-BF57-55E2493A07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BA2BE8-58AB-40A7-868C-3FBEF656473A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056A94-ECEF-4C09-A768-8B6414C8B5C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gif"/><Relationship Id="rId2" Type="http://schemas.openxmlformats.org/officeDocument/2006/relationships/hyperlink" Target="http://www.mmmlib.com/" TargetMode="External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gi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gif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79280" y="3240"/>
            <a:ext cx="8785440" cy="643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 have written a paper about opinion dynamics. Our results include a </a:t>
            </a: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vision of the tetrahedron into four equal parts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Here, we present two animations of it,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de by the Belgian architect Francis Jonckheere. A related division of the tetrahedron into two equal parts has inspired the work of the (late) American architect Anne Tyng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2016000" y="1268280"/>
            <a:ext cx="5112000" cy="325440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1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E8D911-A0E7-44BC-A5D5-3B7E0E7F28FD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4"/>
          <p:cNvSpPr/>
          <p:nvPr/>
        </p:nvSpPr>
        <p:spPr>
          <a:xfrm>
            <a:off x="196200" y="6458040"/>
            <a:ext cx="693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(To view the animations, please watch presentation in Slide Show mode.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Rectangle 5" descr=""/>
          <p:cNvPicPr/>
          <p:nvPr/>
        </p:nvPicPr>
        <p:blipFill>
          <a:blip r:embed="rId1"/>
          <a:stretch/>
        </p:blipFill>
        <p:spPr>
          <a:xfrm>
            <a:off x="85680" y="-79200"/>
            <a:ext cx="9058320" cy="665604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2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72C0D4-67F4-43DB-B533-428782417FC1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68" descr=""/>
          <p:cNvPicPr/>
          <p:nvPr/>
        </p:nvPicPr>
        <p:blipFill>
          <a:blip r:embed="rId2"/>
          <a:stretch/>
        </p:blipFill>
        <p:spPr>
          <a:xfrm>
            <a:off x="324000" y="3782880"/>
            <a:ext cx="3041640" cy="2598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2" descr=""/>
          <p:cNvPicPr/>
          <p:nvPr/>
        </p:nvPicPr>
        <p:blipFill>
          <a:blip r:embed="rId1"/>
          <a:stretch/>
        </p:blipFill>
        <p:spPr>
          <a:xfrm>
            <a:off x="5003640" y="1725480"/>
            <a:ext cx="3743640" cy="3432240"/>
          </a:xfrm>
          <a:prstGeom prst="rect">
            <a:avLst/>
          </a:prstGeom>
          <a:ln w="0">
            <a:noFill/>
          </a:ln>
        </p:spPr>
      </p:pic>
      <p:sp>
        <p:nvSpPr>
          <p:cNvPr id="56" name="Rectangle 9"/>
          <p:cNvSpPr/>
          <p:nvPr/>
        </p:nvSpPr>
        <p:spPr>
          <a:xfrm>
            <a:off x="179280" y="3240"/>
            <a:ext cx="8785440" cy="606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gt; 1, the ODS can no longer be represented in three dimension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4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A7F1C0-21FA-46C1-8184-DEBC16462DB3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2"/>
          <p:cNvSpPr/>
          <p:nvPr/>
        </p:nvSpPr>
        <p:spPr>
          <a:xfrm>
            <a:off x="179280" y="1593720"/>
            <a:ext cx="482436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 represent the opinion dynamics in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 </a:t>
            </a: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pinion density space (ODS)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the simplest case, with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, there are four theories of the world and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ODS has a tetrahedral shape. The vertices correspond to consensus positions on one of the four theorie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ctangle 5"/>
          <p:cNvSpPr/>
          <p:nvPr/>
        </p:nvSpPr>
        <p:spPr>
          <a:xfrm>
            <a:off x="179280" y="3240"/>
            <a:ext cx="8785440" cy="497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1, the bound of confidence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n be 0, 1, or 2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hen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0, the agents only consider as peers others that have exactly the same theory, so there is </a:t>
            </a:r>
            <a:r>
              <a:rPr b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opinion dynamics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hen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, some but not all agents are each other’s peers. In general, such intermediate values for the bound of confidence lead to </a:t>
            </a:r>
            <a:r>
              <a:rPr b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lex behaviour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hen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2, all agents consider each other as epistemic peers, often resulting in a </a:t>
            </a:r>
            <a:r>
              <a:rPr b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pulation-wide consensus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2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C0972D-2B23-40F7-8C97-9C4C9D59A713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4" descr=""/>
          <p:cNvPicPr/>
          <p:nvPr/>
        </p:nvPicPr>
        <p:blipFill>
          <a:blip r:embed="rId1"/>
          <a:stretch/>
        </p:blipFill>
        <p:spPr>
          <a:xfrm>
            <a:off x="4572000" y="2935440"/>
            <a:ext cx="3692520" cy="392256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5"/>
          <p:cNvSpPr/>
          <p:nvPr/>
        </p:nvSpPr>
        <p:spPr>
          <a:xfrm>
            <a:off x="179280" y="3240"/>
            <a:ext cx="8785440" cy="350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 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 and </a:t>
            </a:r>
            <a:r>
              <a:rPr b="0" i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2,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ODS consists of four basins associated with initial profiles that evolve to a consensus on one of the four theorie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art from studying opinion dynamics, the shapes of these basins are interesting in their own right, since they give rise to a </a:t>
            </a:r>
            <a:r>
              <a:rPr b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vision of the tetrahedron into four equal parts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3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B8FD10-6DEF-48D1-AC94-FB08EDBBEBBB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4"/>
          <p:cNvSpPr/>
          <p:nvPr/>
        </p:nvSpPr>
        <p:spPr>
          <a:xfrm>
            <a:off x="179280" y="3803760"/>
            <a:ext cx="410544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our paper, we present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 “exploded view” of the ODS to show the three dimensional shape of the basin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3" descr=""/>
          <p:cNvPicPr/>
          <p:nvPr/>
        </p:nvPicPr>
        <p:blipFill>
          <a:blip r:embed="rId1"/>
          <a:stretch/>
        </p:blipFill>
        <p:spPr>
          <a:xfrm>
            <a:off x="4427640" y="2708280"/>
            <a:ext cx="4159080" cy="415908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5"/>
          <p:cNvSpPr/>
          <p:nvPr/>
        </p:nvSpPr>
        <p:spPr>
          <a:xfrm>
            <a:off x="179280" y="3240"/>
            <a:ext cx="8785440" cy="31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ach basin has the same shape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with five faces: one rhombus,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wo equilateral triangles, and – facing the interior of the ODS –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wo isosceles right triangles) and a volume that occupies one quarter of the tetrahedral OD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3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44B0D9-447F-4829-9577-3D6D54033C03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4"/>
          <p:cNvSpPr/>
          <p:nvPr/>
        </p:nvSpPr>
        <p:spPr>
          <a:xfrm>
            <a:off x="179280" y="3429000"/>
            <a:ext cx="388800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this animation, the four parts move in and out of the center, while the whole rotate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urtesy Francis Jonckheere (</a:t>
            </a:r>
            <a:r>
              <a:rPr b="0" lang="nl-NL" sz="2000" spc="-1" strike="noStrike" u="sng">
                <a:solidFill>
                  <a:srgbClr val="0000ff"/>
                </a:solidFill>
                <a:uFillTx/>
                <a:latin typeface="Times New Roman"/>
                <a:ea typeface="Times New Roman"/>
                <a:hlinkClick r:id="rId2"/>
              </a:rPr>
              <a:t>URL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5"/>
          <p:cNvSpPr/>
          <p:nvPr/>
        </p:nvSpPr>
        <p:spPr>
          <a:xfrm>
            <a:off x="187920" y="6458040"/>
            <a:ext cx="385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(View animations in Slide Show mode.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4" descr=""/>
          <p:cNvPicPr/>
          <p:nvPr/>
        </p:nvPicPr>
        <p:blipFill>
          <a:blip r:embed="rId1"/>
          <a:stretch/>
        </p:blipFill>
        <p:spPr>
          <a:xfrm>
            <a:off x="3995640" y="3068640"/>
            <a:ext cx="5112000" cy="3403440"/>
          </a:xfrm>
          <a:prstGeom prst="rect">
            <a:avLst/>
          </a:prstGeom>
          <a:ln w="0">
            <a:noFill/>
          </a:ln>
        </p:spPr>
      </p:pic>
      <p:sp>
        <p:nvSpPr>
          <p:cNvPr id="71" name="Rectangle 5"/>
          <p:cNvSpPr/>
          <p:nvPr/>
        </p:nvSpPr>
        <p:spPr>
          <a:xfrm>
            <a:off x="179280" y="3240"/>
            <a:ext cx="8785440" cy="31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ach basin has the same shape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with five faces: one rhombus,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wo equilateral triangles, and – facing the interior of the ODS –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wo isosceles right triangles) and a volume that occupies one quarter of the tetrahedral OD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3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1D656B-5949-4ED6-8048-D7134C42B5BD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4"/>
          <p:cNvSpPr/>
          <p:nvPr/>
        </p:nvSpPr>
        <p:spPr>
          <a:xfrm>
            <a:off x="179280" y="3108240"/>
            <a:ext cx="396108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this animation, the four</a:t>
            </a:r>
            <a:br>
              <a:rPr sz="2400"/>
            </a:b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s are rearranged to show</a:t>
            </a:r>
            <a:br>
              <a:rPr sz="2400"/>
            </a:b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at they have an equal shape;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joining two adjacent parts,</a:t>
            </a:r>
            <a:br>
              <a:rPr sz="2400"/>
            </a:b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 get a partition of the</a:t>
            </a:r>
            <a:br>
              <a:rPr sz="2400"/>
            </a:b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hedron into two equal</a:t>
            </a:r>
            <a:br>
              <a:rPr sz="2400"/>
            </a:b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s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urtesy Francis Jonckheere (</a:t>
            </a:r>
            <a:r>
              <a:rPr b="0" lang="nl-NL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L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5"/>
          <p:cNvSpPr/>
          <p:nvPr/>
        </p:nvSpPr>
        <p:spPr>
          <a:xfrm>
            <a:off x="187920" y="6458040"/>
            <a:ext cx="385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(View animations in Slide Show mode.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tangle 5"/>
          <p:cNvSpPr/>
          <p:nvPr/>
        </p:nvSpPr>
        <p:spPr>
          <a:xfrm>
            <a:off x="179280" y="3240"/>
            <a:ext cx="8785440" cy="94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Rationality: A Social-Epistemology Perspectiv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Sylvia Wenmackers, Danny Eric Paul Vanpoucke and Igor Douve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1"/>
          <p:cNvSpPr/>
          <p:nvPr/>
        </p:nvSpPr>
        <p:spPr>
          <a:xfrm>
            <a:off x="7949880" y="649620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620661-AA04-44F0-A68E-0AEF55DB408A}" type="slidenum"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number&gt;</a:t>
            </a:fld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Picture 2" descr=""/>
          <p:cNvPicPr/>
          <p:nvPr/>
        </p:nvPicPr>
        <p:blipFill>
          <a:blip r:embed="rId1"/>
          <a:stretch/>
        </p:blipFill>
        <p:spPr>
          <a:xfrm>
            <a:off x="357120" y="3811680"/>
            <a:ext cx="4143600" cy="2857320"/>
          </a:xfrm>
          <a:prstGeom prst="rect">
            <a:avLst/>
          </a:prstGeom>
          <a:ln w="0">
            <a:noFill/>
          </a:ln>
        </p:spPr>
      </p:pic>
      <p:sp>
        <p:nvSpPr>
          <p:cNvPr id="78" name="Rectangle 6"/>
          <p:cNvSpPr/>
          <p:nvPr/>
        </p:nvSpPr>
        <p:spPr>
          <a:xfrm>
            <a:off x="4284720" y="4097160"/>
            <a:ext cx="4621320" cy="192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ne Tyng also considered a division into four parts, but that is not equal to the one that results from our opinion dynamics study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urtesy Francis Jonckheere (</a:t>
            </a:r>
            <a:r>
              <a:rPr b="0" lang="nl-NL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L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8"/>
          <p:cNvSpPr/>
          <p:nvPr/>
        </p:nvSpPr>
        <p:spPr>
          <a:xfrm>
            <a:off x="179280" y="1557360"/>
            <a:ext cx="511344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closely related division of the </a:t>
            </a:r>
            <a:r>
              <a:rPr b="1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hedron into two equal parts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as inspired the work of the (late) American architect Anne Tyng. She used it in the design of a house for her parents (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alworth Tyng House 1950–’53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nl-NL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L</a:t>
            </a:r>
            <a:r>
              <a:rPr b="0" lang="nl-NL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Picture 4" descr=""/>
          <p:cNvPicPr/>
          <p:nvPr/>
        </p:nvPicPr>
        <p:blipFill>
          <a:blip r:embed="rId2"/>
          <a:stretch/>
        </p:blipFill>
        <p:spPr>
          <a:xfrm>
            <a:off x="5481720" y="1628640"/>
            <a:ext cx="3352680" cy="2183040"/>
          </a:xfrm>
          <a:prstGeom prst="rect">
            <a:avLst/>
          </a:prstGeom>
          <a:ln w="0">
            <a:noFill/>
          </a:ln>
        </p:spPr>
      </p:pic>
      <p:sp>
        <p:nvSpPr>
          <p:cNvPr id="81" name="Rectangle 1"/>
          <p:cNvSpPr/>
          <p:nvPr/>
        </p:nvSpPr>
        <p:spPr>
          <a:xfrm>
            <a:off x="187920" y="6458040"/>
            <a:ext cx="385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(View animations in Slide Show mode.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05T13:41:18Z</dcterms:created>
  <dc:creator>Sylvia</dc:creator>
  <dc:description/>
  <dc:language>en-US</dc:language>
  <cp:lastModifiedBy>Sylvia</cp:lastModifiedBy>
  <dcterms:modified xsi:type="dcterms:W3CDTF">2014-05-21T19:20:18Z</dcterms:modified>
  <cp:revision>2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StageName">
    <vt:lpwstr>Upload</vt:lpwstr>
  </property>
  <property fmtid="{D5CDD505-2E9C-101B-9397-08002B2CF9AE}" pid="6" name="TitleName">
    <vt:lpwstr>Presentation 1.PPT</vt:lpwstr>
  </property>
</Properties>
</file>